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72"/>
  </p:normalViewPr>
  <p:slideViewPr>
    <p:cSldViewPr snapToGrid="0">
      <p:cViewPr>
        <p:scale>
          <a:sx n="83" d="100"/>
          <a:sy n="83" d="100"/>
        </p:scale>
        <p:origin x="2216" y="-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888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1750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9766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0632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18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32346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4455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78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559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15772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693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BD77BFD-EE5C-42F4-A63B-ED041D51B993}" type="datetimeFigureOut">
              <a:rPr kumimoji="1" lang="ja-JP" altLang="en-US" smtClean="0"/>
              <a:t>2025/8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B5D4EC-3F40-41B8-AE66-2C954D5BAF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6108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58974D49-1D8B-3DF2-DF6C-63C9645883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8549798"/>
              </p:ext>
            </p:extLst>
          </p:nvPr>
        </p:nvGraphicFramePr>
        <p:xfrm>
          <a:off x="666232" y="865501"/>
          <a:ext cx="5662281" cy="6660927"/>
        </p:xfrm>
        <a:graphic>
          <a:graphicData uri="http://schemas.openxmlformats.org/drawingml/2006/table">
            <a:tbl>
              <a:tblPr/>
              <a:tblGrid>
                <a:gridCol w="988140">
                  <a:extLst>
                    <a:ext uri="{9D8B030D-6E8A-4147-A177-3AD203B41FA5}">
                      <a16:colId xmlns:a16="http://schemas.microsoft.com/office/drawing/2014/main" val="847702344"/>
                    </a:ext>
                  </a:extLst>
                </a:gridCol>
                <a:gridCol w="1366164">
                  <a:extLst>
                    <a:ext uri="{9D8B030D-6E8A-4147-A177-3AD203B41FA5}">
                      <a16:colId xmlns:a16="http://schemas.microsoft.com/office/drawing/2014/main" val="970131034"/>
                    </a:ext>
                  </a:extLst>
                </a:gridCol>
                <a:gridCol w="1264023">
                  <a:extLst>
                    <a:ext uri="{9D8B030D-6E8A-4147-A177-3AD203B41FA5}">
                      <a16:colId xmlns:a16="http://schemas.microsoft.com/office/drawing/2014/main" val="3362197999"/>
                    </a:ext>
                  </a:extLst>
                </a:gridCol>
                <a:gridCol w="927847">
                  <a:extLst>
                    <a:ext uri="{9D8B030D-6E8A-4147-A177-3AD203B41FA5}">
                      <a16:colId xmlns:a16="http://schemas.microsoft.com/office/drawing/2014/main" val="3359363396"/>
                    </a:ext>
                  </a:extLst>
                </a:gridCol>
                <a:gridCol w="1116107">
                  <a:extLst>
                    <a:ext uri="{9D8B030D-6E8A-4147-A177-3AD203B41FA5}">
                      <a16:colId xmlns:a16="http://schemas.microsoft.com/office/drawing/2014/main" val="2139254449"/>
                    </a:ext>
                  </a:extLst>
                </a:gridCol>
              </a:tblGrid>
              <a:tr h="196781">
                <a:tc gridSpan="5">
                  <a:txBody>
                    <a:bodyPr/>
                    <a:lstStyle/>
                    <a:p>
                      <a:pPr algn="l"/>
                      <a:r>
                        <a:rPr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se 1</a:t>
                      </a:r>
                      <a:endParaRPr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2338723663"/>
                  </a:ext>
                </a:extLst>
              </a:tr>
              <a:tr h="228980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ja-JP" alt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　</a:t>
                      </a:r>
                      <a:endParaRPr lang="ja-JP" alt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efore 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 year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 years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3565298"/>
                  </a:ext>
                </a:extLst>
              </a:tr>
              <a:tr h="168390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MSE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/30 points)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5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8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8267037"/>
                  </a:ext>
                </a:extLst>
              </a:tr>
              <a:tr h="168390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CMT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/36 points)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7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5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4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1974314"/>
                  </a:ext>
                </a:extLst>
              </a:tr>
              <a:tr h="168390">
                <a:tc rowSpan="6"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AIS III subtests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scaled score)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Vocabulary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200016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git symbol coding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00853924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T w="12700" cmpd="sng">
                      <a:noFill/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git span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75585298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rithmetic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910291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endParaRPr lang="en-US" sz="105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  <a:prstDash val="solid"/>
                    </a:lnT>
                    <a:lnB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icture completion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0205836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lock design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4323904"/>
                  </a:ext>
                </a:extLst>
              </a:tr>
              <a:tr h="16839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AB</a:t>
                      </a: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8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8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87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2684470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quential command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0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0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95%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1783490"/>
                  </a:ext>
                </a:extLst>
              </a:tr>
              <a:tr h="168390">
                <a:tc gridSpan="5">
                  <a:txBody>
                    <a:bodyPr/>
                    <a:lstStyle/>
                    <a:p>
                      <a:pPr algn="l" fontAlgn="base">
                        <a:lnSpc>
                          <a:spcPts val="1575"/>
                        </a:lnSpc>
                      </a:pP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69189358"/>
                  </a:ext>
                </a:extLst>
              </a:tr>
              <a:tr h="168390">
                <a:tc gridSpan="5">
                  <a:txBody>
                    <a:bodyPr/>
                    <a:lstStyle/>
                    <a:p>
                      <a:pPr algn="l" fontAlgn="base">
                        <a:lnSpc>
                          <a:spcPts val="1575"/>
                        </a:lnSpc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Case 2</a:t>
                      </a: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</a:tcPr>
                </a:tc>
                <a:extLst>
                  <a:ext uri="{0D108BD9-81ED-4DB2-BD59-A6C34878D82A}">
                    <a16:rowId xmlns:a16="http://schemas.microsoft.com/office/drawing/2014/main" val="3440009090"/>
                  </a:ext>
                </a:extLst>
              </a:tr>
              <a:tr h="226146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ja-JP" alt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　</a:t>
                      </a:r>
                      <a:endParaRPr lang="ja-JP" alt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endParaRPr lang="ja-JP" alt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efore</a:t>
                      </a:r>
                      <a:endParaRPr lang="ja-JP" alt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 year</a:t>
                      </a:r>
                      <a:endParaRPr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 years</a:t>
                      </a:r>
                      <a:endParaRPr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1008806"/>
                  </a:ext>
                </a:extLst>
              </a:tr>
              <a:tr h="168390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MMSE 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/30 points)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5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Arial" panose="020B060402020202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0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Arial" panose="020B060402020202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7027535"/>
                  </a:ext>
                </a:extLst>
              </a:tr>
              <a:tr h="168390"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CMT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/36 points)</a:t>
                      </a: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7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kumimoji="1" lang="en-US" altLang="ja-JP" sz="105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5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Arial" panose="020B060402020202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4</a:t>
                      </a:r>
                      <a:endParaRPr lang="en-US" altLang="ja-JP" sz="105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Arial" panose="020B060402020202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39981231"/>
                  </a:ext>
                </a:extLst>
              </a:tr>
              <a:tr h="168390">
                <a:tc rowSpan="6"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AIS III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ubtests</a:t>
                      </a:r>
                    </a:p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(scaled score)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lnSpc>
                          <a:spcPts val="1575"/>
                        </a:lnSpc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Vocabulary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4</a:t>
                      </a:r>
                      <a:endParaRPr lang="en-US" altLang="ja-JP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6172375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git symbol coding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3200486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igit span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4664629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 dirty="0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rithmetic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2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439680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endParaRPr lang="en-US" sz="1050" b="0" i="0" dirty="0">
                        <a:solidFill>
                          <a:srgbClr val="000000"/>
                        </a:solidFill>
                        <a:effectLst/>
                      </a:endParaRPr>
                    </a:p>
                  </a:txBody>
                  <a:tcPr marL="53323" marR="53323" marT="26661" marB="26661" anchor="ctr"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ase">
                        <a:lnSpc>
                          <a:spcPts val="1575"/>
                        </a:lnSpc>
                      </a:pPr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Picture completion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13219370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Block design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kumimoji="1" lang="ja-JP" altLang="en-US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altLang="ja-JP" sz="105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 panose="020B060402020202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261597"/>
                  </a:ext>
                </a:extLst>
              </a:tr>
              <a:tr h="168390">
                <a:tc row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AB</a:t>
                      </a:r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total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54%</a:t>
                      </a:r>
                      <a:endParaRPr kumimoji="1" lang="en-US" altLang="ja-JP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7%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4%</a:t>
                      </a:r>
                      <a:endParaRPr lang="en-US" sz="1050" b="0" i="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64754123"/>
                  </a:ext>
                </a:extLst>
              </a:tr>
              <a:tr h="168390">
                <a:tc vMerge="1">
                  <a:txBody>
                    <a:bodyPr/>
                    <a:lstStyle/>
                    <a:p>
                      <a:pPr algn="ctr"/>
                      <a:endParaRPr kumimoji="1" lang="en-US" altLang="ja-JP" dirty="0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equential command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0%</a:t>
                      </a:r>
                      <a:endParaRPr kumimoji="1" lang="en-US" altLang="ja-JP" sz="105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6%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ts val="1575"/>
                        </a:lnSpc>
                      </a:pPr>
                      <a:r>
                        <a:rPr lang="en-US" sz="1050" b="0" i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7%</a:t>
                      </a:r>
                    </a:p>
                  </a:txBody>
                  <a:tcPr marL="53323" marR="53323" marT="26661" marB="26661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7974991"/>
                  </a:ext>
                </a:extLst>
              </a:tr>
            </a:tbl>
          </a:graphicData>
        </a:graphic>
      </p:graphicFrame>
      <p:sp>
        <p:nvSpPr>
          <p:cNvPr id="10" name="テキスト ボックス 13">
            <a:extLst>
              <a:ext uri="{FF2B5EF4-FFF2-40B4-BE49-F238E27FC236}">
                <a16:creationId xmlns:a16="http://schemas.microsoft.com/office/drawing/2014/main" id="{4B8DDC49-0DC5-CDA6-5B34-C6D0C462A34B}"/>
              </a:ext>
            </a:extLst>
          </p:cNvPr>
          <p:cNvSpPr txBox="1"/>
          <p:nvPr/>
        </p:nvSpPr>
        <p:spPr>
          <a:xfrm>
            <a:off x="582876" y="7741770"/>
            <a:ext cx="5818594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900" kern="100" dirty="0">
                <a:effectLst/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Abbreviation: MMSE, Mini Mental State Examination; RCMT, Raven colored matrices test, Japanese edition; WAIS-III, Wechsler’s measurement, and appraisal of adult intelligence, 3</a:t>
            </a:r>
            <a:r>
              <a:rPr lang="en-US" altLang="ja-JP" sz="900" kern="100" baseline="30000" dirty="0">
                <a:effectLst/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 </a:t>
            </a:r>
            <a:r>
              <a:rPr lang="en-US" altLang="ja-JP" sz="900" kern="100" dirty="0" err="1">
                <a:effectLst/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rd</a:t>
            </a:r>
            <a:r>
              <a:rPr lang="en-US" altLang="ja-JP" sz="900" kern="100" dirty="0">
                <a:effectLst/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 edition of Japanese version; WAB,</a:t>
            </a:r>
            <a:r>
              <a:rPr lang="ja-JP" altLang="en-US" sz="900" kern="100" dirty="0"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 </a:t>
            </a:r>
            <a:r>
              <a:rPr lang="en-US" altLang="ja-JP" sz="900" kern="100" dirty="0"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The</a:t>
            </a:r>
            <a:r>
              <a:rPr lang="ja-JP" altLang="en-US" sz="900" kern="100" dirty="0"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 </a:t>
            </a:r>
            <a:r>
              <a:rPr lang="en-US" altLang="ja-JP" sz="900" kern="100" dirty="0"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Western Aphasia Battery,</a:t>
            </a:r>
            <a:r>
              <a:rPr lang="en-US" altLang="ja-JP" sz="900" kern="100" dirty="0">
                <a:effectLst/>
                <a:latin typeface="Calibri" panose="020F0502020204030204" pitchFamily="34" charset="0"/>
                <a:ea typeface="ＭＳ ゴシック" panose="020B0609070205080204" pitchFamily="49" charset="-128"/>
                <a:cs typeface="Calibri" panose="020F0502020204030204" pitchFamily="34" charset="0"/>
              </a:rPr>
              <a:t> Japanese edition. </a:t>
            </a:r>
            <a:endParaRPr lang="en-US" altLang="ja-JP" sz="900" dirty="0">
              <a:solidFill>
                <a:srgbClr val="000000"/>
              </a:solidFill>
              <a:latin typeface="Calibri" panose="020F0502020204030204" pitchFamily="34" charset="0"/>
              <a:ea typeface="ＭＳ ゴシック" panose="020B0609070205080204" pitchFamily="49" charset="-128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CB82C34-4CD0-9A6C-648B-0C1ED9DB6A87}"/>
              </a:ext>
            </a:extLst>
          </p:cNvPr>
          <p:cNvSpPr txBox="1"/>
          <p:nvPr/>
        </p:nvSpPr>
        <p:spPr>
          <a:xfrm>
            <a:off x="509919" y="303762"/>
            <a:ext cx="5964509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Calibri" panose="020F0502020204030204" pitchFamily="34" charset="0"/>
                <a:cs typeface="Calibri" panose="020F0502020204030204" pitchFamily="34" charset="0"/>
              </a:rPr>
              <a:t>Supplementary Table. Longitudinal changes in neuropsychological tests before,1 year, and 2 years after tafamidis meglumine administration</a:t>
            </a:r>
          </a:p>
        </p:txBody>
      </p:sp>
    </p:spTree>
    <p:extLst>
      <p:ext uri="{BB962C8B-B14F-4D97-AF65-F5344CB8AC3E}">
        <p14:creationId xmlns:p14="http://schemas.microsoft.com/office/powerpoint/2010/main" val="40084352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3</TotalTime>
  <Words>219</Words>
  <Application>Microsoft Macintosh PowerPoint</Application>
  <PresentationFormat>A4 210 x 297 mm</PresentationFormat>
  <Paragraphs>10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黒羽　泰子／Kuroha,Yasuko</dc:creator>
  <cp:lastModifiedBy>Natsumi Saito</cp:lastModifiedBy>
  <cp:revision>11</cp:revision>
  <dcterms:created xsi:type="dcterms:W3CDTF">2025-01-10T10:47:46Z</dcterms:created>
  <dcterms:modified xsi:type="dcterms:W3CDTF">2025-08-09T05:59:10Z</dcterms:modified>
</cp:coreProperties>
</file>